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9" r:id="rId4"/>
    <p:sldId id="257" r:id="rId5"/>
    <p:sldId id="262" r:id="rId6"/>
    <p:sldId id="260" r:id="rId7"/>
    <p:sldId id="263" r:id="rId8"/>
    <p:sldId id="261" r:id="rId9"/>
    <p:sldId id="265" r:id="rId10"/>
    <p:sldId id="264" r:id="rId11"/>
    <p:sldId id="267" r:id="rId12"/>
    <p:sldId id="266" r:id="rId13"/>
    <p:sldId id="271" r:id="rId14"/>
    <p:sldId id="268" r:id="rId15"/>
    <p:sldId id="270" r:id="rId16"/>
    <p:sldId id="269" r:id="rId17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3" autoAdjust="0"/>
    <p:restoredTop sz="94660"/>
  </p:normalViewPr>
  <p:slideViewPr>
    <p:cSldViewPr snapToGrid="0">
      <p:cViewPr varScale="1">
        <p:scale>
          <a:sx n="94" d="100"/>
          <a:sy n="94" d="100"/>
        </p:scale>
        <p:origin x="96" y="6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24BCDC2-2081-584D-269D-CAF287A90B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F7C107F-AB66-2A51-81B4-82DF1505B4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8FD6E78-BB2B-38F4-8ADE-CF68DF2FFA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2D4092F-FB2E-6CA4-355D-274F7DF19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19B2A14-D7F3-FAD4-1A9F-107963E65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21825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1AD9008-9A7C-3EF7-A6FC-71786E7DFE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7922CC7-4E3C-500B-CD02-3FAD55CAA2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4157F13-A167-6A8D-FEDF-892D741CC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96179F2-82CE-4CCF-682D-D465DDA43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47A1228-70FC-D250-84DE-1E126D8EE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81500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C2159EB-CD50-FBA1-1925-852570BD26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E466F19-F902-8688-0187-146A3D879F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3E5C966-FCB7-EF20-E2EA-653DF3194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122D0FA-C83F-3657-4386-4CCC9CEED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EBF8050-EA8A-1003-1E04-3944F3F7C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51825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DF85148-C19D-9EF7-46AF-299B11D392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C4B9237-AF6E-FC43-7288-3E1901C25E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9753090-EEC0-9BB2-5C87-E78E1BADBB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03E06E9-8BEC-9C35-4CC6-4CA93561E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CE8E17D-DEB7-1865-37F2-78330A283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51913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1EB53BE-40DA-AFF6-1053-B2E9087A1E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6B506D2-58F9-3D05-7437-320D08BDE3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ECBC637-C7FB-1B0C-C41E-8B853028F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91D4D7B-6A10-01C6-72D0-7C5E46A895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7CB31D9-117B-7960-F39A-57FECE470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572303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3939C0-A123-956F-B10F-D126795633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24D8027-2B18-51BC-292D-87758F8FCB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7BCE435-150B-85C7-EDBB-C888866CFB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65621F3-EF57-10E1-131B-D4E184B66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3FD02F5-B6DD-EB50-0C43-9BC69E688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5F3AC5B-43E5-77E6-173F-857C92085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1769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ACA20B6-8664-6C0D-05F2-0C0D74ECAE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2DD45A6-E275-9FC5-71A1-BF86AD2CB8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EC34F65-C316-1080-0898-CDBE4D20F4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1B886CF-3147-CCC9-10B0-022C7EAD53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396024B-76DE-A4CC-4567-8FB5E64DEE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D7CCD9AD-1C15-E681-F9C8-415B35E361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41463F81-1708-8F50-E762-724BAC062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B88A0714-15F0-BDB5-B98E-8D4FC38B1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210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D0595DB-210B-43C7-F18D-19276BAA8D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D4173D11-3D95-BBF0-23B9-663DE4CCB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D842E0AA-14EB-4A7C-9F50-06781DE71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9255D85A-2681-98B1-CDAA-EB39EBBE0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357483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DD659F0E-22A1-7177-1EDD-439DF855B7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B6AEBA00-36DB-72A6-F741-937881A173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2FCDFD2-6F06-3A02-330E-B7F2289422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72671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C2A84A-B4BF-DA75-8D96-8E5210245F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D3FFFB8-E77C-F543-F8B6-2B63A991DE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E0934FF-4450-62C7-55BD-707CB34045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65C63AC-B811-63CE-F28F-985749382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F0E4FAE-411A-95E3-3EAA-4F170C8E7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99FED11-BF6B-CD0A-E310-9CE58967FD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191714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0DC79F7-CB0E-1B71-8EA2-3C85229F2B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7E45ECAF-BE6F-D609-F3D1-082168B7EC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24B65E1-A21D-E4E5-DD14-C43276590C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30A8496-1CC1-9125-EF4F-7363E48CB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45AB3E2-F39C-A053-F00E-56DC4A98A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330EFA7-3047-61B9-0E5D-C535A6B00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373674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E70F6C86-4B54-A7DC-8AA9-BEB7FA05A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7F01313-F536-E768-F49F-7DB7E19DD6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4195FCE-7A76-82EF-35DD-25ADF2D2CA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9FEEEE-DF7E-4A72-8D29-F6C116DEE33F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0D70671-AF20-B3A4-2D93-350ECC9688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2C87673-8437-887F-89BF-0544EE6850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F81906-EC35-4D17-872B-4F0D99D52C3B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48069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5D90AB41-22D2-D652-FF76-61043198D4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948E5A37-89E7-727C-E985-F5B82A57EE7B}"/>
              </a:ext>
            </a:extLst>
          </p:cNvPr>
          <p:cNvSpPr txBox="1"/>
          <p:nvPr/>
        </p:nvSpPr>
        <p:spPr>
          <a:xfrm>
            <a:off x="4866640" y="82625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1 COX1</a:t>
            </a:r>
          </a:p>
        </p:txBody>
      </p:sp>
    </p:spTree>
    <p:extLst>
      <p:ext uri="{BB962C8B-B14F-4D97-AF65-F5344CB8AC3E}">
        <p14:creationId xmlns:p14="http://schemas.microsoft.com/office/powerpoint/2010/main" val="9938438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8589749B-5A16-D031-EC2D-E934703FF7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8DAA474A-1677-5110-5D99-9B9D173251C0}"/>
              </a:ext>
            </a:extLst>
          </p:cNvPr>
          <p:cNvSpPr txBox="1"/>
          <p:nvPr/>
        </p:nvSpPr>
        <p:spPr>
          <a:xfrm>
            <a:off x="4998720" y="88721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3 (COX1) B-ACTIN</a:t>
            </a:r>
          </a:p>
        </p:txBody>
      </p:sp>
    </p:spTree>
    <p:extLst>
      <p:ext uri="{BB962C8B-B14F-4D97-AF65-F5344CB8AC3E}">
        <p14:creationId xmlns:p14="http://schemas.microsoft.com/office/powerpoint/2010/main" val="11969938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03D51A5B-665B-19BD-E13F-E5E3BA7D3D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0088649D-3BCA-3AC7-9320-1FDCEDA53C04}"/>
              </a:ext>
            </a:extLst>
          </p:cNvPr>
          <p:cNvSpPr txBox="1"/>
          <p:nvPr/>
        </p:nvSpPr>
        <p:spPr>
          <a:xfrm>
            <a:off x="5321218" y="933844"/>
            <a:ext cx="609814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3 COX2</a:t>
            </a:r>
          </a:p>
        </p:txBody>
      </p:sp>
    </p:spTree>
    <p:extLst>
      <p:ext uri="{BB962C8B-B14F-4D97-AF65-F5344CB8AC3E}">
        <p14:creationId xmlns:p14="http://schemas.microsoft.com/office/powerpoint/2010/main" val="194470556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Diagrama&#10;&#10;Descripción generada automáticamente">
            <a:extLst>
              <a:ext uri="{FF2B5EF4-FFF2-40B4-BE49-F238E27FC236}">
                <a16:creationId xmlns:a16="http://schemas.microsoft.com/office/drawing/2014/main" id="{D0A28057-53BE-66C7-D904-5B63D25A56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DE676B70-3B08-4DDA-15D5-0DC156D325D6}"/>
              </a:ext>
            </a:extLst>
          </p:cNvPr>
          <p:cNvSpPr txBox="1"/>
          <p:nvPr/>
        </p:nvSpPr>
        <p:spPr>
          <a:xfrm>
            <a:off x="4767036" y="864571"/>
            <a:ext cx="609814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3 (COX2) B-ACTIN</a:t>
            </a:r>
          </a:p>
        </p:txBody>
      </p:sp>
    </p:spTree>
    <p:extLst>
      <p:ext uri="{BB962C8B-B14F-4D97-AF65-F5344CB8AC3E}">
        <p14:creationId xmlns:p14="http://schemas.microsoft.com/office/powerpoint/2010/main" val="119019321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Gráfico, Diagrama&#10;&#10;Descripción generada automáticamente">
            <a:extLst>
              <a:ext uri="{FF2B5EF4-FFF2-40B4-BE49-F238E27FC236}">
                <a16:creationId xmlns:a16="http://schemas.microsoft.com/office/drawing/2014/main" id="{502DF28E-9362-6AEF-66DD-3A13AFC9D78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1274AD7C-B74B-B064-65C2-919E215076F6}"/>
              </a:ext>
            </a:extLst>
          </p:cNvPr>
          <p:cNvSpPr txBox="1"/>
          <p:nvPr/>
        </p:nvSpPr>
        <p:spPr>
          <a:xfrm>
            <a:off x="5252720" y="59257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4 COX1</a:t>
            </a:r>
          </a:p>
        </p:txBody>
      </p:sp>
    </p:spTree>
    <p:extLst>
      <p:ext uri="{BB962C8B-B14F-4D97-AF65-F5344CB8AC3E}">
        <p14:creationId xmlns:p14="http://schemas.microsoft.com/office/powerpoint/2010/main" val="204772965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Diagrama&#10;&#10;Descripción generada automáticamente con confianza media">
            <a:extLst>
              <a:ext uri="{FF2B5EF4-FFF2-40B4-BE49-F238E27FC236}">
                <a16:creationId xmlns:a16="http://schemas.microsoft.com/office/drawing/2014/main" id="{5747EAF9-853C-F984-0063-A2011A851E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850D0579-B517-26F0-328E-DF3E5C00D00C}"/>
              </a:ext>
            </a:extLst>
          </p:cNvPr>
          <p:cNvSpPr txBox="1"/>
          <p:nvPr/>
        </p:nvSpPr>
        <p:spPr>
          <a:xfrm>
            <a:off x="4888033" y="981873"/>
            <a:ext cx="609814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4 (COX1) B-ACTIN</a:t>
            </a:r>
          </a:p>
        </p:txBody>
      </p:sp>
    </p:spTree>
    <p:extLst>
      <p:ext uri="{BB962C8B-B14F-4D97-AF65-F5344CB8AC3E}">
        <p14:creationId xmlns:p14="http://schemas.microsoft.com/office/powerpoint/2010/main" val="278810525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0D3E6DFF-B786-0568-C7BE-D099BDE53B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F8FF47F5-C722-A7A1-415C-BFBC4D96873C}"/>
              </a:ext>
            </a:extLst>
          </p:cNvPr>
          <p:cNvSpPr txBox="1"/>
          <p:nvPr/>
        </p:nvSpPr>
        <p:spPr>
          <a:xfrm>
            <a:off x="5069840" y="93801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4 COX2</a:t>
            </a:r>
          </a:p>
        </p:txBody>
      </p:sp>
    </p:spTree>
    <p:extLst>
      <p:ext uri="{BB962C8B-B14F-4D97-AF65-F5344CB8AC3E}">
        <p14:creationId xmlns:p14="http://schemas.microsoft.com/office/powerpoint/2010/main" val="123872886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Diagrama&#10;&#10;Descripción generada automáticamente">
            <a:extLst>
              <a:ext uri="{FF2B5EF4-FFF2-40B4-BE49-F238E27FC236}">
                <a16:creationId xmlns:a16="http://schemas.microsoft.com/office/drawing/2014/main" id="{B8CF048A-9252-32FE-75C0-CC74371A6A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7EE9975E-720F-A31B-6A71-6B061E46467A}"/>
              </a:ext>
            </a:extLst>
          </p:cNvPr>
          <p:cNvSpPr txBox="1"/>
          <p:nvPr/>
        </p:nvSpPr>
        <p:spPr>
          <a:xfrm>
            <a:off x="4836160" y="79577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4 (COX2) B-ACTIN</a:t>
            </a:r>
          </a:p>
        </p:txBody>
      </p:sp>
    </p:spTree>
    <p:extLst>
      <p:ext uri="{BB962C8B-B14F-4D97-AF65-F5344CB8AC3E}">
        <p14:creationId xmlns:p14="http://schemas.microsoft.com/office/powerpoint/2010/main" val="15839578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63C8EECC-21B6-141A-650E-DEB8ADE16B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79B8B5FB-8628-D746-BBC1-1DDCAE42314A}"/>
              </a:ext>
            </a:extLst>
          </p:cNvPr>
          <p:cNvSpPr txBox="1"/>
          <p:nvPr/>
        </p:nvSpPr>
        <p:spPr>
          <a:xfrm>
            <a:off x="4358640" y="866894"/>
            <a:ext cx="29972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1 (COX1) B-ACTIN</a:t>
            </a:r>
          </a:p>
        </p:txBody>
      </p:sp>
    </p:spTree>
    <p:extLst>
      <p:ext uri="{BB962C8B-B14F-4D97-AF65-F5344CB8AC3E}">
        <p14:creationId xmlns:p14="http://schemas.microsoft.com/office/powerpoint/2010/main" val="5010388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Gráfico, Diagrama, Gráfico de líneas&#10;&#10;Descripción generada automáticamente">
            <a:extLst>
              <a:ext uri="{FF2B5EF4-FFF2-40B4-BE49-F238E27FC236}">
                <a16:creationId xmlns:a16="http://schemas.microsoft.com/office/drawing/2014/main" id="{E1C87DE9-38A2-81CB-55C7-9B7F354E90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4B77A7CD-BC2B-878E-F795-E83EDDB6CA3E}"/>
              </a:ext>
            </a:extLst>
          </p:cNvPr>
          <p:cNvSpPr txBox="1"/>
          <p:nvPr/>
        </p:nvSpPr>
        <p:spPr>
          <a:xfrm>
            <a:off x="4897120" y="82625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1 COX2</a:t>
            </a:r>
          </a:p>
        </p:txBody>
      </p:sp>
    </p:spTree>
    <p:extLst>
      <p:ext uri="{BB962C8B-B14F-4D97-AF65-F5344CB8AC3E}">
        <p14:creationId xmlns:p14="http://schemas.microsoft.com/office/powerpoint/2010/main" val="2375859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Diagrama&#10;&#10;Descripción generada automáticamente">
            <a:extLst>
              <a:ext uri="{FF2B5EF4-FFF2-40B4-BE49-F238E27FC236}">
                <a16:creationId xmlns:a16="http://schemas.microsoft.com/office/drawing/2014/main" id="{6B1C1346-0BA9-5720-1575-8071D4BEBA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26F08877-848E-8317-1A1A-B91F5C3B6E41}"/>
              </a:ext>
            </a:extLst>
          </p:cNvPr>
          <p:cNvSpPr txBox="1"/>
          <p:nvPr/>
        </p:nvSpPr>
        <p:spPr>
          <a:xfrm>
            <a:off x="4551680" y="72465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1 (COX2) B-ACTIN</a:t>
            </a:r>
          </a:p>
        </p:txBody>
      </p:sp>
    </p:spTree>
    <p:extLst>
      <p:ext uri="{BB962C8B-B14F-4D97-AF65-F5344CB8AC3E}">
        <p14:creationId xmlns:p14="http://schemas.microsoft.com/office/powerpoint/2010/main" val="15834840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A97F0CC3-6A8B-3B74-5B0A-4A3DC67198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8BEE7E96-ECEB-AC38-DB93-81D3301420E8}"/>
              </a:ext>
            </a:extLst>
          </p:cNvPr>
          <p:cNvSpPr txBox="1"/>
          <p:nvPr/>
        </p:nvSpPr>
        <p:spPr>
          <a:xfrm>
            <a:off x="5262880" y="79577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2 COX1</a:t>
            </a:r>
          </a:p>
        </p:txBody>
      </p:sp>
    </p:spTree>
    <p:extLst>
      <p:ext uri="{BB962C8B-B14F-4D97-AF65-F5344CB8AC3E}">
        <p14:creationId xmlns:p14="http://schemas.microsoft.com/office/powerpoint/2010/main" val="33556117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F8162268-D04A-BB31-13CA-913C513639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B1D1C7DF-A35E-569F-128A-6E9452E268FA}"/>
              </a:ext>
            </a:extLst>
          </p:cNvPr>
          <p:cNvSpPr txBox="1"/>
          <p:nvPr/>
        </p:nvSpPr>
        <p:spPr>
          <a:xfrm>
            <a:off x="4226560" y="87705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2 (COX1) B-ACTIN</a:t>
            </a:r>
          </a:p>
        </p:txBody>
      </p:sp>
    </p:spTree>
    <p:extLst>
      <p:ext uri="{BB962C8B-B14F-4D97-AF65-F5344CB8AC3E}">
        <p14:creationId xmlns:p14="http://schemas.microsoft.com/office/powerpoint/2010/main" val="13742473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BB301E4E-CEBD-A548-96B4-86F618165D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E715C3D9-573E-421E-524D-318B70A78229}"/>
              </a:ext>
            </a:extLst>
          </p:cNvPr>
          <p:cNvSpPr txBox="1"/>
          <p:nvPr/>
        </p:nvSpPr>
        <p:spPr>
          <a:xfrm>
            <a:off x="5405120" y="9075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2 COX2</a:t>
            </a:r>
          </a:p>
        </p:txBody>
      </p:sp>
    </p:spTree>
    <p:extLst>
      <p:ext uri="{BB962C8B-B14F-4D97-AF65-F5344CB8AC3E}">
        <p14:creationId xmlns:p14="http://schemas.microsoft.com/office/powerpoint/2010/main" val="19910428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Diagrama&#10;&#10;Descripción generada automáticamente">
            <a:extLst>
              <a:ext uri="{FF2B5EF4-FFF2-40B4-BE49-F238E27FC236}">
                <a16:creationId xmlns:a16="http://schemas.microsoft.com/office/drawing/2014/main" id="{48B1632E-23E5-204F-E78B-4185C7810A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E11A772D-45E8-B538-464F-746253B86D0C}"/>
              </a:ext>
            </a:extLst>
          </p:cNvPr>
          <p:cNvSpPr txBox="1"/>
          <p:nvPr/>
        </p:nvSpPr>
        <p:spPr>
          <a:xfrm>
            <a:off x="4460240" y="8567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2 (COX2) B-ACTIN</a:t>
            </a:r>
          </a:p>
        </p:txBody>
      </p:sp>
    </p:spTree>
    <p:extLst>
      <p:ext uri="{BB962C8B-B14F-4D97-AF65-F5344CB8AC3E}">
        <p14:creationId xmlns:p14="http://schemas.microsoft.com/office/powerpoint/2010/main" val="5755745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Diagrama&#10;&#10;Descripción generada automáticamente">
            <a:extLst>
              <a:ext uri="{FF2B5EF4-FFF2-40B4-BE49-F238E27FC236}">
                <a16:creationId xmlns:a16="http://schemas.microsoft.com/office/drawing/2014/main" id="{2C27BCEE-29D1-70FD-F071-0851604619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8FB26EC5-BCE4-12A7-0271-0E1126FA9530}"/>
              </a:ext>
            </a:extLst>
          </p:cNvPr>
          <p:cNvSpPr txBox="1"/>
          <p:nvPr/>
        </p:nvSpPr>
        <p:spPr>
          <a:xfrm>
            <a:off x="4632960" y="8567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dirty="0" err="1"/>
              <a:t>Plots</a:t>
            </a:r>
            <a:r>
              <a:rPr lang="es-CL" dirty="0"/>
              <a:t> </a:t>
            </a:r>
            <a:r>
              <a:rPr lang="es-CL" dirty="0" err="1"/>
              <a:t>of</a:t>
            </a:r>
            <a:r>
              <a:rPr lang="es-CL" dirty="0"/>
              <a:t> N3 COX1</a:t>
            </a:r>
          </a:p>
        </p:txBody>
      </p:sp>
      <p:pic>
        <p:nvPicPr>
          <p:cNvPr id="7" name="Imagen 6" descr="Gráfico, Histograma&#10;&#10;Descripción generada automáticamente">
            <a:extLst>
              <a:ext uri="{FF2B5EF4-FFF2-40B4-BE49-F238E27FC236}">
                <a16:creationId xmlns:a16="http://schemas.microsoft.com/office/drawing/2014/main" id="{0FC81823-2A16-E460-1098-4A620A5091F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375" y="1795462"/>
            <a:ext cx="6191250" cy="3267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60507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88</Words>
  <Application>Microsoft Office PowerPoint</Application>
  <PresentationFormat>Panorámica</PresentationFormat>
  <Paragraphs>16</Paragraphs>
  <Slides>1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6</vt:i4>
      </vt:variant>
    </vt:vector>
  </HeadingPairs>
  <TitlesOfParts>
    <vt:vector size="20" baseType="lpstr">
      <vt:lpstr>Aptos</vt:lpstr>
      <vt:lpstr>Aptos Display</vt:lpstr>
      <vt:lpstr>Arial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Diego Maya Arango (jdmaya)</dc:creator>
  <cp:lastModifiedBy>Juan Diego Maya Arango (jdmaya)</cp:lastModifiedBy>
  <cp:revision>1</cp:revision>
  <dcterms:created xsi:type="dcterms:W3CDTF">2024-05-20T15:14:05Z</dcterms:created>
  <dcterms:modified xsi:type="dcterms:W3CDTF">2024-05-20T15:29:19Z</dcterms:modified>
</cp:coreProperties>
</file>